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10086" r:id="rId2"/>
    <p:sldId id="1008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82"/>
  </p:normalViewPr>
  <p:slideViewPr>
    <p:cSldViewPr snapToGrid="0" showGuides="1">
      <p:cViewPr>
        <p:scale>
          <a:sx n="75" d="100"/>
          <a:sy n="75" d="100"/>
        </p:scale>
        <p:origin x="1992" y="84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C70976-C7EE-5F1C-2B8F-36C2C17AD09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9739635-C06E-54CA-4EA7-7546F5EEEEE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85B569-551E-9F0E-D659-5A117E4C09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967AE-5D65-C244-AE1B-1709FA625A89}" type="datetimeFigureOut">
              <a:rPr lang="en-US" smtClean="0"/>
              <a:t>12/1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95B4A4-BC1D-44B2-7296-25075E5ACF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30F94A-4FAE-D819-121B-49ACDE8FAB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33DD3-F0B3-BA48-A25D-31AA27C39E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822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A48734-EB41-9509-121A-1E729912F0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85B2716-17BD-4316-A122-C70406D22F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1C3A84-857B-646A-0FBD-2D1DE7EB78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967AE-5D65-C244-AE1B-1709FA625A89}" type="datetimeFigureOut">
              <a:rPr lang="en-US" smtClean="0"/>
              <a:t>12/1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7C3117-19CB-9AF3-8DF3-C058E6085A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CCDFD6-E713-5905-6EA7-6B2217EB36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33DD3-F0B3-BA48-A25D-31AA27C39E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8710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0872570-109E-541C-BD3F-60395CCA916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7021ECD-FF98-3BF1-D572-5B9B838078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0C5DDE-986F-862E-ECB7-D29A4060B3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967AE-5D65-C244-AE1B-1709FA625A89}" type="datetimeFigureOut">
              <a:rPr lang="en-US" smtClean="0"/>
              <a:t>12/1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C86EC0-8A58-E08C-3A8E-4BE271CF1E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F1C321-3F6B-5B63-AACC-A01EB76652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33DD3-F0B3-BA48-A25D-31AA27C39E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74175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655A11-FF8F-81C0-BF32-4A74F47AB8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FEB201-0691-B60A-52E9-323D9C6E2C7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2BA26A-D639-0E2F-0DEB-DF9DD15A8D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967AE-5D65-C244-AE1B-1709FA625A89}" type="datetimeFigureOut">
              <a:rPr lang="en-US" smtClean="0"/>
              <a:t>12/1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BFAB0C-7254-0353-10B9-D0463AFF1B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997477-3FFE-9F41-4382-2B39A3A1D9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33DD3-F0B3-BA48-A25D-31AA27C39E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84508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FA2F8A-D1D9-999E-A054-F2571E167C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A75237A-69EC-A8D5-2E2C-DE8AC8B816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27CE3F-BEFC-8418-6F3A-BD9D0EE955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967AE-5D65-C244-AE1B-1709FA625A89}" type="datetimeFigureOut">
              <a:rPr lang="en-US" smtClean="0"/>
              <a:t>12/1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058024-ED19-4980-5DC2-EDF6B45B17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90B8CB-7FBE-1DD0-D7CE-42F4F8EA5E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33DD3-F0B3-BA48-A25D-31AA27C39E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6755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E1C25B-34B9-330B-CF11-792C1CC6C3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ED56A3-6C86-F344-3541-E6C9F28121F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3B247CC-2577-725E-E2FC-F8BC2C026F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9539F7-5EF6-8E09-BB8B-6AFC3D3478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967AE-5D65-C244-AE1B-1709FA625A89}" type="datetimeFigureOut">
              <a:rPr lang="en-US" smtClean="0"/>
              <a:t>12/1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C31873E-67E7-3532-006B-5B4938E25B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AB7FA27-8B93-614E-EC78-E6F7E051BD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33DD3-F0B3-BA48-A25D-31AA27C39E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3389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F1B006-8410-BE4A-648F-B908328271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73FB7D-D86A-2D7C-29F1-B677D80017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B7E44E6-E776-B9E0-5741-0B36ED83B8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4191BD0-9B61-CA70-B0A3-C16E7F9DEAA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C4F0E2A-69B0-DC75-108A-1FD6477BF13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1386C4B-15DD-DB85-E21D-1BD604B181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967AE-5D65-C244-AE1B-1709FA625A89}" type="datetimeFigureOut">
              <a:rPr lang="en-US" smtClean="0"/>
              <a:t>12/11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05B5EC4-14F0-2E81-EB91-200E6131E7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28F5C34-5CCC-4D8A-DA14-4CDCFB7E16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33DD3-F0B3-BA48-A25D-31AA27C39E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82129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54D73D-566E-1C7D-E900-76B1A2F020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A2087AF-F960-A34B-79A1-D7A05CECF7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967AE-5D65-C244-AE1B-1709FA625A89}" type="datetimeFigureOut">
              <a:rPr lang="en-US" smtClean="0"/>
              <a:t>12/11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978E5A9-8848-A8B0-E2AA-A0F366EED7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EFC9C9D-9329-B057-335D-3D898C7A12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33DD3-F0B3-BA48-A25D-31AA27C39E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53871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38EDF35-83BF-1762-51A9-C6DB3D1FC7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967AE-5D65-C244-AE1B-1709FA625A89}" type="datetimeFigureOut">
              <a:rPr lang="en-US" smtClean="0"/>
              <a:t>12/11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9BB4882-71FE-6DCE-6497-A6933E3F1B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FDC199B-C08D-F35C-FF7D-13A78E2021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33DD3-F0B3-BA48-A25D-31AA27C39E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99953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44DDA1-AA68-5DB8-F460-DA11543519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7ADEB43-3F80-2F38-81B0-3509B4FAE94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BDC6B3A-2C87-D06A-A634-C5E533AB7A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5A383D-F055-22F7-81C9-9D40E4C28F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967AE-5D65-C244-AE1B-1709FA625A89}" type="datetimeFigureOut">
              <a:rPr lang="en-US" smtClean="0"/>
              <a:t>12/1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F48889-A446-6D5C-11C1-BD4294AA55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C1347B5-2505-A845-9726-C4C347B839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33DD3-F0B3-BA48-A25D-31AA27C39E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72979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7926F7-DC3D-BDDA-6EE8-74D9BC0A30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201E5A3-2528-6FEB-DF28-33199729C9E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2F2E8E0-459C-89AF-B173-D3ADB93C4F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0536ED3-21F6-33D2-FC75-B1AECF2051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967AE-5D65-C244-AE1B-1709FA625A89}" type="datetimeFigureOut">
              <a:rPr lang="en-US" smtClean="0"/>
              <a:t>12/1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F936F44-E2BF-C10E-7BE0-29F63AE5D3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8B6346-2AC0-8E4E-107C-A8E2337664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33DD3-F0B3-BA48-A25D-31AA27C39E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11907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5B60F6F-45FC-9173-7CC2-9F30622194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324E61-5FEA-1337-7752-2545868F39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7254A9-C972-DA65-7FA9-A06DCC9BAC3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15967AE-5D65-C244-AE1B-1709FA625A89}" type="datetimeFigureOut">
              <a:rPr lang="en-US" smtClean="0"/>
              <a:t>12/1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9AE145-D1D1-6C43-6D84-5D91BEA3F86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41F7EB-611E-F526-728D-775528FA4ED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2333DD3-F0B3-BA48-A25D-31AA27C39E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1661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3" Type="http://schemas.microsoft.com/office/2007/relationships/media" Target="../media/media2.mp4"/><Relationship Id="rId7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video" Target="../media/media3.mp4"/><Relationship Id="rId5" Type="http://schemas.microsoft.com/office/2007/relationships/media" Target="../media/media3.mp4"/><Relationship Id="rId10" Type="http://schemas.openxmlformats.org/officeDocument/2006/relationships/image" Target="../media/image3.png"/><Relationship Id="rId4" Type="http://schemas.openxmlformats.org/officeDocument/2006/relationships/video" Target="../media/media2.mp4"/><Relationship Id="rId9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media" Target="../media/media5.mp4"/><Relationship Id="rId7" Type="http://schemas.openxmlformats.org/officeDocument/2006/relationships/slideLayout" Target="../slideLayouts/slideLayout2.xml"/><Relationship Id="rId2" Type="http://schemas.openxmlformats.org/officeDocument/2006/relationships/video" Target="../media/media4.mp4"/><Relationship Id="rId1" Type="http://schemas.microsoft.com/office/2007/relationships/media" Target="../media/media4.mp4"/><Relationship Id="rId6" Type="http://schemas.openxmlformats.org/officeDocument/2006/relationships/video" Target="../media/media6.mp4"/><Relationship Id="rId5" Type="http://schemas.microsoft.com/office/2007/relationships/media" Target="../media/media6.mp4"/><Relationship Id="rId10" Type="http://schemas.openxmlformats.org/officeDocument/2006/relationships/image" Target="../media/image6.png"/><Relationship Id="rId4" Type="http://schemas.openxmlformats.org/officeDocument/2006/relationships/video" Target="../media/media5.mp4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Movie 2 Take 2 All_D2_6_corrected_cropped_labeled_scalebar_burned">
            <a:hlinkClick r:id="" action="ppaction://media"/>
            <a:extLst>
              <a:ext uri="{FF2B5EF4-FFF2-40B4-BE49-F238E27FC236}">
                <a16:creationId xmlns:a16="http://schemas.microsoft.com/office/drawing/2014/main" id="{749D5AC6-F6BD-87BC-3C8E-A572921DE86D}"/>
              </a:ext>
            </a:extLst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1540967" y="694564"/>
            <a:ext cx="2675853" cy="2006611"/>
          </a:xfrm>
        </p:spPr>
      </p:pic>
      <p:pic>
        <p:nvPicPr>
          <p:cNvPr id="6" name="Movie 2 Take 2 Red Green_D2_6_corrected_cropped_labeled_scalebar_burned">
            <a:hlinkClick r:id="" action="ppaction://media"/>
            <a:extLst>
              <a:ext uri="{FF2B5EF4-FFF2-40B4-BE49-F238E27FC236}">
                <a16:creationId xmlns:a16="http://schemas.microsoft.com/office/drawing/2014/main" id="{F9A136BD-65D1-1613-BBF8-956A1ACE3654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1540967" y="2740617"/>
            <a:ext cx="1295400" cy="874197"/>
          </a:xfrm>
          <a:prstGeom prst="rect">
            <a:avLst/>
          </a:prstGeom>
        </p:spPr>
      </p:pic>
      <p:pic>
        <p:nvPicPr>
          <p:cNvPr id="7" name="Movie 2 Take 2 Red_D2_6_corrected_cropped_scalebar_labeled_burned">
            <a:hlinkClick r:id="" action="ppaction://media"/>
            <a:extLst>
              <a:ext uri="{FF2B5EF4-FFF2-40B4-BE49-F238E27FC236}">
                <a16:creationId xmlns:a16="http://schemas.microsoft.com/office/drawing/2014/main" id="{0153CD01-AFE0-5AA9-6B2A-3737AB06E911}"/>
              </a:ext>
            </a:extLst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2921420" y="2740618"/>
            <a:ext cx="1295400" cy="874196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07AF1441-2BBC-B417-7D51-204B35A8BD8A}"/>
              </a:ext>
            </a:extLst>
          </p:cNvPr>
          <p:cNvSpPr txBox="1"/>
          <p:nvPr/>
        </p:nvSpPr>
        <p:spPr>
          <a:xfrm>
            <a:off x="1540967" y="690058"/>
            <a:ext cx="1457926" cy="656846"/>
          </a:xfrm>
          <a:prstGeom prst="rect">
            <a:avLst/>
          </a:prstGeom>
          <a:solidFill>
            <a:srgbClr val="FFFFFF">
              <a:alpha val="74902"/>
            </a:srgbClr>
          </a:solidFill>
        </p:spPr>
        <p:txBody>
          <a:bodyPr wrap="square" rtlCol="0">
            <a:spAutoFit/>
          </a:bodyPr>
          <a:lstStyle/>
          <a:p>
            <a:r>
              <a:rPr lang="en-US" sz="917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mor Cells</a:t>
            </a:r>
          </a:p>
          <a:p>
            <a:r>
              <a:rPr lang="en-US" sz="917" b="1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nexin V</a:t>
            </a:r>
          </a:p>
          <a:p>
            <a:r>
              <a:rPr lang="en-US" sz="917" b="1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25</a:t>
            </a:r>
            <a:r>
              <a:rPr lang="en-US" sz="917" b="1" baseline="3000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17" b="1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/CD127</a:t>
            </a:r>
            <a:r>
              <a:rPr lang="en-US" sz="917" b="1" baseline="3000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917" b="1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D4 Treg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7B24E48-7F4F-7217-900A-45090AD93579}"/>
              </a:ext>
            </a:extLst>
          </p:cNvPr>
          <p:cNvSpPr txBox="1"/>
          <p:nvPr/>
        </p:nvSpPr>
        <p:spPr>
          <a:xfrm>
            <a:off x="4551023" y="690058"/>
            <a:ext cx="6100010" cy="195438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buNone/>
            </a:pPr>
            <a:r>
              <a:rPr lang="en-US" sz="11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Video 1. Flow cytometry–sorted Tregs kill B78-D14 cells </a:t>
            </a:r>
            <a:r>
              <a:rPr lang="en-US" sz="1100" b="1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vitro</a:t>
            </a:r>
            <a:r>
              <a:rPr lang="en-US" sz="11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uring coculture (example #1). </a:t>
            </a:r>
            <a:r>
              <a:rPr lang="en-US" sz="1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D4⁺ Tregs (gray), obtained from TDLN of B78-D14-bearing mice, were cocultured with B78-D14⁺NLS-mKate2 tumor cells (red) in the presence of  Annexin V–488. When B78-D14⁺NLS-mKate2 cells undergo apoptosis following interactions with Tregs, they lose their red fluorescent signal and become green due to Annexin V–488 uptake. The top panel displays phase-contrast images overlaid with green and red fluorescence. The bottom left panel shows only green and red fluorescence, highlighting the transition of tumor cells from red to green as they </a:t>
            </a:r>
            <a:r>
              <a:rPr lang="en-US" sz="1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poptose</a:t>
            </a:r>
            <a:r>
              <a:rPr lang="en-US" sz="1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The bottom right panel displays only the red fluorescence channel, allowing visualization of the loss of red signal corresponding to tumor cell death. (Time lapse shown is 23:20 </a:t>
            </a:r>
            <a:r>
              <a:rPr lang="en-US" sz="1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n:seconds</a:t>
            </a:r>
            <a:r>
              <a:rPr lang="en-US" sz="1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or all 3 panels of the same cells, taken with different filters). </a:t>
            </a:r>
            <a:endParaRPr lang="en-US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algn="just">
              <a:buNone/>
            </a:pPr>
            <a:r>
              <a:rPr lang="en-US" sz="11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6510408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410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14100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4" dur="14100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5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16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7" fill="hold">
                      <p:stCondLst>
                        <p:cond delay="0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0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21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22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3" fill="hold">
                      <p:stCondLst>
                        <p:cond delay="0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6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  <p:video>
              <p:cMediaNode vol="80000">
                <p:cTn id="27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  <p:seq concurrent="1" nextAc="seek">
              <p:cTn id="28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9" fill="hold">
                      <p:stCondLst>
                        <p:cond delay="0"/>
                      </p:stCondLst>
                      <p:childTnLst>
                        <p:par>
                          <p:cTn id="30" fill="hold">
                            <p:stCondLst>
                              <p:cond delay="0"/>
                            </p:stCondLst>
                            <p:childTnLst>
                              <p:par>
                                <p:cTn id="3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2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True Tregs + B78 MHCII_D2_3_corrected_cropped_labeled_burned">
            <a:hlinkClick r:id="" action="ppaction://media"/>
            <a:extLst>
              <a:ext uri="{FF2B5EF4-FFF2-40B4-BE49-F238E27FC236}">
                <a16:creationId xmlns:a16="http://schemas.microsoft.com/office/drawing/2014/main" id="{D3FA715D-03A8-0020-52BC-BC27407CADA0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1532543" y="713230"/>
            <a:ext cx="2412333" cy="2007870"/>
          </a:xfrm>
          <a:prstGeom prst="rect">
            <a:avLst/>
          </a:prstGeom>
        </p:spPr>
      </p:pic>
      <p:pic>
        <p:nvPicPr>
          <p:cNvPr id="9" name="Tregs + MHCII Red only_D2_3_corrected_cropped_labeled_burned">
            <a:hlinkClick r:id="" action="ppaction://media"/>
            <a:extLst>
              <a:ext uri="{FF2B5EF4-FFF2-40B4-BE49-F238E27FC236}">
                <a16:creationId xmlns:a16="http://schemas.microsoft.com/office/drawing/2014/main" id="{5BA827D9-410A-EC31-1D32-A9ABBE29878D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2763927" y="2761930"/>
            <a:ext cx="1180948" cy="988866"/>
          </a:xfrm>
          <a:prstGeom prst="rect">
            <a:avLst/>
          </a:prstGeom>
        </p:spPr>
      </p:pic>
      <p:pic>
        <p:nvPicPr>
          <p:cNvPr id="10" name="Tregs + MHCII G+R_D2_3_corrected_cropped_labeled_burned">
            <a:hlinkClick r:id="" action="ppaction://media"/>
            <a:extLst>
              <a:ext uri="{FF2B5EF4-FFF2-40B4-BE49-F238E27FC236}">
                <a16:creationId xmlns:a16="http://schemas.microsoft.com/office/drawing/2014/main" id="{A8672833-78AD-FCC7-EA50-D22C16183FD9}"/>
              </a:ext>
            </a:extLst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1532543" y="2760823"/>
            <a:ext cx="1180948" cy="98886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1B93254-1D16-9086-3A75-104EF4E9284D}"/>
              </a:ext>
            </a:extLst>
          </p:cNvPr>
          <p:cNvSpPr txBox="1"/>
          <p:nvPr/>
        </p:nvSpPr>
        <p:spPr>
          <a:xfrm>
            <a:off x="1532543" y="713230"/>
            <a:ext cx="1459230" cy="656846"/>
          </a:xfrm>
          <a:prstGeom prst="rect">
            <a:avLst/>
          </a:prstGeom>
          <a:solidFill>
            <a:srgbClr val="FFFFFF">
              <a:alpha val="74902"/>
            </a:srgbClr>
          </a:solidFill>
        </p:spPr>
        <p:txBody>
          <a:bodyPr wrap="square" rtlCol="0">
            <a:spAutoFit/>
          </a:bodyPr>
          <a:lstStyle/>
          <a:p>
            <a:r>
              <a:rPr lang="en-US" sz="917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mor Cells</a:t>
            </a:r>
          </a:p>
          <a:p>
            <a:r>
              <a:rPr lang="en-US" sz="917" b="1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nexin V</a:t>
            </a:r>
          </a:p>
          <a:p>
            <a:r>
              <a:rPr lang="en-US" sz="917" b="1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25</a:t>
            </a:r>
            <a:r>
              <a:rPr lang="en-US" sz="917" b="1" baseline="3000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17" b="1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/CD127</a:t>
            </a:r>
            <a:r>
              <a:rPr lang="en-US" sz="917" b="1" baseline="3000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917" b="1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D4 Treg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74BA204-6DDF-16F6-A730-323C4B5C3E3E}"/>
              </a:ext>
            </a:extLst>
          </p:cNvPr>
          <p:cNvSpPr txBox="1"/>
          <p:nvPr/>
        </p:nvSpPr>
        <p:spPr>
          <a:xfrm>
            <a:off x="4188089" y="713230"/>
            <a:ext cx="6100010" cy="19389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buNone/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Video 2. Flow cytometry–sorted Tregs kill B78-D14 cells </a:t>
            </a:r>
            <a:r>
              <a:rPr lang="en-US" sz="1200" b="1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vitro 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uring coculture (example #2).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D4⁺ Tregs (gray), obtained from TDLN of B78-D14-bearing mice, were cocultured with B78-D14⁺NLS-mKate2 tumor cells (red) in the presence of Annexin V–488. When B78-D14⁺NLS-mKate2 cells undergo apoptosis following interactions with Tregs, they lose their red fluorescent signal and become green due to Annexin V–488 uptake. The top panel displays phase-contrast images overlaid with green and red fluorescence. The bottom left panel shows only green and red fluorescence, highlighting the transition of tumor cells from red to green as they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poptose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The bottom right panel displays only the red fluorescence channel, allowing visualization of the loss of red signal corresponding to tumor cell death.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Time lapse shown is 15:20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n:seconds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or all 3 panels of the same cells, taken with different filters). 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179578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9300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9300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4" dur="9300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5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  <p:seq concurrent="1" nextAc="seek">
              <p:cTn id="16" restart="whenNotActive" fill="hold" evtFilter="cancelBubble" nodeType="interactiveSeq">
                <p:stCondLst>
                  <p:cond evt="onClick" delay="0">
                    <p:tgtEl>
                      <p:spTgt spid="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7" fill="hold">
                      <p:stCondLst>
                        <p:cond delay="0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0" dur="1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8"/>
                  </p:tgtEl>
                </p:cond>
              </p:nextCondLst>
            </p:seq>
            <p:video>
              <p:cMediaNode vol="80000">
                <p:cTn id="21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  <p:seq concurrent="1" nextAc="seek">
              <p:cTn id="22" restart="whenNotActive" fill="hold" evtFilter="cancelBubble" nodeType="interactiveSeq">
                <p:stCondLst>
                  <p:cond evt="onClick" delay="0">
                    <p:tgtEl>
                      <p:spTgt spid="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3" fill="hold">
                      <p:stCondLst>
                        <p:cond delay="0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6" dur="1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9"/>
                  </p:tgtEl>
                </p:cond>
              </p:nextCondLst>
            </p:seq>
            <p:video>
              <p:cMediaNode vol="80000">
                <p:cTn id="27" fill="hold" display="0">
                  <p:stCondLst>
                    <p:cond delay="indefinite"/>
                  </p:stCondLst>
                </p:cTn>
                <p:tgtEl>
                  <p:spTgt spid="10"/>
                </p:tgtEl>
              </p:cMediaNode>
            </p:video>
            <p:seq concurrent="1" nextAc="seek">
              <p:cTn id="28" restart="whenNotActive" fill="hold" evtFilter="cancelBubble" nodeType="interactiveSeq">
                <p:stCondLst>
                  <p:cond evt="onClick" delay="0">
                    <p:tgtEl>
                      <p:spTgt spid="1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9" fill="hold">
                      <p:stCondLst>
                        <p:cond delay="0"/>
                      </p:stCondLst>
                      <p:childTnLst>
                        <p:par>
                          <p:cTn id="30" fill="hold">
                            <p:stCondLst>
                              <p:cond delay="0"/>
                            </p:stCondLst>
                            <p:childTnLst>
                              <p:par>
                                <p:cTn id="3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2" dur="1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0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57</Words>
  <Application>Microsoft Macintosh PowerPoint</Application>
  <PresentationFormat>Widescreen</PresentationFormat>
  <Paragraphs>9</Paragraphs>
  <Slides>2</Slides>
  <Notes>0</Notes>
  <HiddenSlides>0</HiddenSlides>
  <MMClips>6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my Erbe- Gurel</dc:creator>
  <cp:lastModifiedBy>Amy Erbe- Gurel</cp:lastModifiedBy>
  <cp:revision>1</cp:revision>
  <dcterms:created xsi:type="dcterms:W3CDTF">2025-12-12T05:27:17Z</dcterms:created>
  <dcterms:modified xsi:type="dcterms:W3CDTF">2025-12-12T05:30:17Z</dcterms:modified>
</cp:coreProperties>
</file>